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F9BBFE-0168-42A2-8494-3DA51C92CE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991A73-58F8-4043-A369-C603933B17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949E5A-EA3C-41FA-AC03-DACD184946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827E6-DA15-4E74-A944-EC6519DEB7B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590DE3-6270-4D78-8A6B-082C688C21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F1ABA0-D602-4BEA-B376-D4F84D0DE7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09B26-5A81-4141-85CE-BD85DE84DD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36C0E-D115-49A9-8A32-6E3FDE5CBC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FBAE51-0C9B-4F9B-891B-C92CF87617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6FC9F1-F551-4310-B9D2-5E7509FFBC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A11E8F-6EA4-4376-B69F-9015E95C38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3D175-751D-4A3E-8B6E-D57BD2A1E9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4510B5-2D6F-444A-9B91-034C53C2D14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rowth rates as a function of sulfuric acid and highly oxygenated molecule (HOM) concentrations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2171880" y="1523880"/>
            <a:ext cx="4800600" cy="38401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D:\PPT_Out\nature-logo.jpg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J Tröstl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 et al. Nature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33,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527–531 (2016) doi:10.1038/nature1827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18T09:40:57Z</dcterms:created>
  <dc:creator>ravikumar.n</dc:creator>
  <dc:description/>
  <dc:language>en-US</dc:language>
  <cp:lastModifiedBy>R.Vijitha</cp:lastModifiedBy>
  <dcterms:modified xsi:type="dcterms:W3CDTF">2016-05-18T09:43:05Z</dcterms:modified>
  <cp:revision>2</cp:revision>
  <dc:subject/>
  <dc:title>Growth rates as a function of sulfuric acid and highly oxygenated molecule (HOM) concentrations</dc:title>
</cp:coreProperties>
</file>